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4" r:id="rId4"/>
    <p:sldId id="265" r:id="rId5"/>
    <p:sldId id="266" r:id="rId6"/>
    <p:sldId id="267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1450" y="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1/23/Wed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10" Type="http://schemas.openxmlformats.org/officeDocument/2006/relationships/image" Target="../media/image21.tiff"/><Relationship Id="rId4" Type="http://schemas.openxmlformats.org/officeDocument/2006/relationships/image" Target="../media/image15.tiff"/><Relationship Id="rId9" Type="http://schemas.openxmlformats.org/officeDocument/2006/relationships/image" Target="../media/image2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10" Type="http://schemas.openxmlformats.org/officeDocument/2006/relationships/image" Target="../media/image21.tiff"/><Relationship Id="rId4" Type="http://schemas.openxmlformats.org/officeDocument/2006/relationships/image" Target="../media/image15.tiff"/><Relationship Id="rId9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z-fan\肖海\睾丸 HE 染色\HE 阴性组\HE  阴性组   200倍-0002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5856" y="1052736"/>
            <a:ext cx="2868760" cy="2160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z-fan\肖海\睾丸 HE 染色\HE 低剂量组\HE 低剂量组  200倍-0006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5664" y="1052736"/>
            <a:ext cx="2868758" cy="2160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z-fan\肖海\睾丸 HE 染色\HE 阳性组\HE 阳性组   200倍-001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183" y="1073942"/>
            <a:ext cx="2840597" cy="21390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标题 1"/>
          <p:cNvSpPr txBox="1">
            <a:spLocks/>
          </p:cNvSpPr>
          <p:nvPr/>
        </p:nvSpPr>
        <p:spPr>
          <a:xfrm>
            <a:off x="1115616" y="620688"/>
            <a:ext cx="1008112" cy="43204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标题 1"/>
          <p:cNvSpPr txBox="1">
            <a:spLocks/>
          </p:cNvSpPr>
          <p:nvPr/>
        </p:nvSpPr>
        <p:spPr>
          <a:xfrm>
            <a:off x="3779913" y="624519"/>
            <a:ext cx="1728191" cy="43204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6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Low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6732241" y="628350"/>
            <a:ext cx="1728191" cy="43204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6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-High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4800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E:\z-fan\2022\TUNEL A N 2022.1.17\Y组\Y组_5.1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4677" y="2646694"/>
            <a:ext cx="1083442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E:\z-fan\2022\TUNEL A N 2022.1.17\Y组\Y组_5.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9999" y="2637719"/>
            <a:ext cx="1083442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E:\z-fan\2022\TUNEL A N 2022.1.17\Y组\Y组_5.3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0968" y="2637719"/>
            <a:ext cx="1083442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E:\z-fan\2022\TUNEL A N 2022.1.17\C组\C组_2.1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94678" y="1525005"/>
            <a:ext cx="1083443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E:\z-fan\2022\TUNEL A N 2022.1.17\C组\C组_2.2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9999" y="1525006"/>
            <a:ext cx="1083442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E:\z-fan\2022\TUNEL A N 2022.1.17\C组\C组_2.3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5319" y="1525004"/>
            <a:ext cx="1083442" cy="10846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文本框 9">
            <a:extLst>
              <a:ext uri="{FF2B5EF4-FFF2-40B4-BE49-F238E27FC236}">
                <a16:creationId xmlns:a16="http://schemas.microsoft.com/office/drawing/2014/main" id="{FACBDBA2-B437-4F0E-9229-67AB1D837690}"/>
              </a:ext>
            </a:extLst>
          </p:cNvPr>
          <p:cNvSpPr txBox="1"/>
          <p:nvPr/>
        </p:nvSpPr>
        <p:spPr>
          <a:xfrm>
            <a:off x="2577970" y="1223153"/>
            <a:ext cx="8062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TUNEL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文本框 10">
            <a:extLst>
              <a:ext uri="{FF2B5EF4-FFF2-40B4-BE49-F238E27FC236}">
                <a16:creationId xmlns:a16="http://schemas.microsoft.com/office/drawing/2014/main" id="{7CA66779-875E-4C3F-9218-46A16F4C4633}"/>
              </a:ext>
            </a:extLst>
          </p:cNvPr>
          <p:cNvSpPr txBox="1"/>
          <p:nvPr/>
        </p:nvSpPr>
        <p:spPr>
          <a:xfrm>
            <a:off x="3889588" y="1219975"/>
            <a:ext cx="58426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DAPI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文本框 11">
            <a:extLst>
              <a:ext uri="{FF2B5EF4-FFF2-40B4-BE49-F238E27FC236}">
                <a16:creationId xmlns:a16="http://schemas.microsoft.com/office/drawing/2014/main" id="{C55F6003-DBEB-409B-946E-5E6C39A52C7E}"/>
              </a:ext>
            </a:extLst>
          </p:cNvPr>
          <p:cNvSpPr txBox="1"/>
          <p:nvPr/>
        </p:nvSpPr>
        <p:spPr>
          <a:xfrm>
            <a:off x="4973143" y="1214754"/>
            <a:ext cx="71909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Merged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标题 1"/>
          <p:cNvSpPr txBox="1">
            <a:spLocks/>
          </p:cNvSpPr>
          <p:nvPr/>
        </p:nvSpPr>
        <p:spPr>
          <a:xfrm>
            <a:off x="1751093" y="1895348"/>
            <a:ext cx="756084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1751094" y="2967910"/>
            <a:ext cx="660668" cy="461090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</a:t>
            </a:r>
          </a:p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300μM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98964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 txBox="1">
            <a:spLocks/>
          </p:cNvSpPr>
          <p:nvPr/>
        </p:nvSpPr>
        <p:spPr>
          <a:xfrm>
            <a:off x="1860790" y="3045212"/>
            <a:ext cx="756084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标题 1"/>
          <p:cNvSpPr txBox="1">
            <a:spLocks/>
          </p:cNvSpPr>
          <p:nvPr/>
        </p:nvSpPr>
        <p:spPr>
          <a:xfrm>
            <a:off x="3859014" y="3048085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Low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6073260" y="3050958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High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C65C32C6-129D-8668-0D77-129F823F35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125" y="3374871"/>
            <a:ext cx="2130447" cy="160427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A41F56F-BF04-8112-1F58-A36DEC4DC38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2401" y="3374870"/>
            <a:ext cx="2125953" cy="160089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D6551BA-7593-74D6-A7DA-CF3F7FFCFA1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6729" y="3369248"/>
            <a:ext cx="2151569" cy="1600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72973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FACBDBA2-B437-4F0E-9229-67AB1D837690}"/>
              </a:ext>
            </a:extLst>
          </p:cNvPr>
          <p:cNvSpPr txBox="1"/>
          <p:nvPr/>
        </p:nvSpPr>
        <p:spPr>
          <a:xfrm>
            <a:off x="1169622" y="2071881"/>
            <a:ext cx="8062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TUNEL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CA66779-875E-4C3F-9218-46A16F4C4633}"/>
              </a:ext>
            </a:extLst>
          </p:cNvPr>
          <p:cNvSpPr txBox="1"/>
          <p:nvPr/>
        </p:nvSpPr>
        <p:spPr>
          <a:xfrm>
            <a:off x="1169622" y="3173350"/>
            <a:ext cx="7020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DAPI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55F6003-DBEB-409B-946E-5E6C39A52C7E}"/>
              </a:ext>
            </a:extLst>
          </p:cNvPr>
          <p:cNvSpPr txBox="1"/>
          <p:nvPr/>
        </p:nvSpPr>
        <p:spPr>
          <a:xfrm>
            <a:off x="1082509" y="4339711"/>
            <a:ext cx="8062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Merged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2114919" y="1322766"/>
            <a:ext cx="756084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标题 1"/>
          <p:cNvSpPr txBox="1">
            <a:spLocks/>
          </p:cNvSpPr>
          <p:nvPr/>
        </p:nvSpPr>
        <p:spPr>
          <a:xfrm>
            <a:off x="4193960" y="1182585"/>
            <a:ext cx="1080119" cy="46421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300μM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+ 2-APB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标题 1"/>
          <p:cNvSpPr txBox="1">
            <a:spLocks/>
          </p:cNvSpPr>
          <p:nvPr/>
        </p:nvSpPr>
        <p:spPr>
          <a:xfrm>
            <a:off x="2922767" y="1302923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300μM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616D062-3B81-92F2-F3BC-CBE107A9A2E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315" y="1626959"/>
            <a:ext cx="1093976" cy="10846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9AF5AC5-9D90-B7D5-B94D-633C35650D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530" y="2736119"/>
            <a:ext cx="1095760" cy="108468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3047F53-8738-B7E6-92E5-5D6C621BA8C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528" y="3859792"/>
            <a:ext cx="1095761" cy="10944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AD92016-AEBA-5B32-D3BB-454BBC6CF4D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658" y="1626960"/>
            <a:ext cx="1065539" cy="10701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3512DF9-037C-347C-3278-90EB9941281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478" y="2736121"/>
            <a:ext cx="1065540" cy="108468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C771089-E269-9ED1-6A9F-6CEB9EC4B9C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591" y="3859790"/>
            <a:ext cx="1065539" cy="109445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370E9C8-501B-FB99-AF68-6CDAEF02D9E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207" y="1631383"/>
            <a:ext cx="1093976" cy="106793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FB4FE0F-BF9E-0C54-89A4-43192569CAE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179614" y="2736119"/>
            <a:ext cx="1094464" cy="109445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98904DA-43AA-455D-860C-C4C23C52051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614" y="3859789"/>
            <a:ext cx="1094464" cy="1094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80945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标题 1"/>
          <p:cNvSpPr txBox="1">
            <a:spLocks/>
          </p:cNvSpPr>
          <p:nvPr/>
        </p:nvSpPr>
        <p:spPr>
          <a:xfrm>
            <a:off x="1860790" y="3045212"/>
            <a:ext cx="756084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标题 1"/>
          <p:cNvSpPr txBox="1">
            <a:spLocks/>
          </p:cNvSpPr>
          <p:nvPr/>
        </p:nvSpPr>
        <p:spPr>
          <a:xfrm>
            <a:off x="3859014" y="3048085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Low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6073260" y="3050958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High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C65C32C6-129D-8668-0D77-129F823F35F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0125" y="3374871"/>
            <a:ext cx="2130447" cy="160427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A41F56F-BF04-8112-1F58-A36DEC4DC38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2401" y="3374870"/>
            <a:ext cx="2125953" cy="160089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D6551BA-7593-74D6-A7DA-CF3F7FFCFA1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6729" y="3369248"/>
            <a:ext cx="2151569" cy="1600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26080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FACBDBA2-B437-4F0E-9229-67AB1D837690}"/>
              </a:ext>
            </a:extLst>
          </p:cNvPr>
          <p:cNvSpPr txBox="1"/>
          <p:nvPr/>
        </p:nvSpPr>
        <p:spPr>
          <a:xfrm>
            <a:off x="1169622" y="2071881"/>
            <a:ext cx="8062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TUNEL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CA66779-875E-4C3F-9218-46A16F4C4633}"/>
              </a:ext>
            </a:extLst>
          </p:cNvPr>
          <p:cNvSpPr txBox="1"/>
          <p:nvPr/>
        </p:nvSpPr>
        <p:spPr>
          <a:xfrm>
            <a:off x="1169622" y="3173350"/>
            <a:ext cx="702079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DAPI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55F6003-DBEB-409B-946E-5E6C39A52C7E}"/>
              </a:ext>
            </a:extLst>
          </p:cNvPr>
          <p:cNvSpPr txBox="1"/>
          <p:nvPr/>
        </p:nvSpPr>
        <p:spPr>
          <a:xfrm>
            <a:off x="1082509" y="4339711"/>
            <a:ext cx="80620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0" b="1" dirty="0">
                <a:latin typeface="Times New Roman" pitchFamily="18" charset="0"/>
                <a:cs typeface="Times New Roman" pitchFamily="18" charset="0"/>
              </a:rPr>
              <a:t>Merged</a:t>
            </a:r>
            <a:endParaRPr lang="zh-CN" altLang="en-US" sz="135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2114919" y="1322766"/>
            <a:ext cx="756084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NC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标题 1"/>
          <p:cNvSpPr txBox="1">
            <a:spLocks/>
          </p:cNvSpPr>
          <p:nvPr/>
        </p:nvSpPr>
        <p:spPr>
          <a:xfrm>
            <a:off x="4193960" y="1182585"/>
            <a:ext cx="1080119" cy="464218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300μM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+ KN93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标题 1"/>
          <p:cNvSpPr txBox="1">
            <a:spLocks/>
          </p:cNvSpPr>
          <p:nvPr/>
        </p:nvSpPr>
        <p:spPr>
          <a:xfrm>
            <a:off x="2922767" y="1302923"/>
            <a:ext cx="1296143" cy="324036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YCl</a:t>
            </a:r>
            <a:r>
              <a:rPr lang="en-US" altLang="zh-CN" sz="1200" b="1" baseline="-25000" dirty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altLang="zh-CN" sz="1200" b="1" dirty="0">
                <a:latin typeface="Times New Roman" pitchFamily="18" charset="0"/>
                <a:cs typeface="Times New Roman" pitchFamily="18" charset="0"/>
              </a:rPr>
              <a:t>-300μM</a:t>
            </a:r>
            <a:endParaRPr lang="zh-CN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616D062-3B81-92F2-F3BC-CBE107A9A2E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0315" y="1626959"/>
            <a:ext cx="1093976" cy="108468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9AF5AC5-9D90-B7D5-B94D-633C35650D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530" y="2736119"/>
            <a:ext cx="1095760" cy="108468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3047F53-8738-B7E6-92E5-5D6C621BA8C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8528" y="3859792"/>
            <a:ext cx="1095761" cy="109445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2AD92016-AEBA-5B32-D3BB-454BBC6CF4D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658" y="1626960"/>
            <a:ext cx="1065539" cy="1070176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B3512DF9-037C-347C-3278-90EB9941281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6478" y="2736121"/>
            <a:ext cx="1065540" cy="108468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4C771089-E269-9ED1-6A9F-6CEB9EC4B9C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5591" y="3859790"/>
            <a:ext cx="1065539" cy="1094450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370E9C8-501B-FB99-AF68-6CDAEF02D9E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4207" y="1631383"/>
            <a:ext cx="1093976" cy="1067931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3FB4FE0F-BF9E-0C54-89A4-43192569CAE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179614" y="2736119"/>
            <a:ext cx="1094464" cy="109445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98904DA-43AA-455D-860C-C4C23C520519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614" y="3859789"/>
            <a:ext cx="1094464" cy="1094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68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31</Words>
  <Application>Microsoft Office PowerPoint</Application>
  <PresentationFormat>全屏显示(4:3)</PresentationFormat>
  <Paragraphs>2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w</cp:lastModifiedBy>
  <cp:revision>4</cp:revision>
  <dcterms:created xsi:type="dcterms:W3CDTF">2022-01-14T12:28:59Z</dcterms:created>
  <dcterms:modified xsi:type="dcterms:W3CDTF">2022-11-23T14:01:59Z</dcterms:modified>
</cp:coreProperties>
</file>